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63" d="100"/>
          <a:sy n="63" d="100"/>
        </p:scale>
        <p:origin x="32" y="1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9295436-F587-C760-63AD-F19EF72AC11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970658B0-824A-284A-A561-0DE3BE34738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C835A71-6C4E-43C3-CF53-7BCF406F8C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FE34A3-6E95-4BE9-9402-403D8E3FBF59}" type="datetimeFigureOut">
              <a:rPr kumimoji="1" lang="ja-JP" altLang="en-US" smtClean="0"/>
              <a:t>2025/1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D32657B-C7F5-0C1D-BAF9-62511C397B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FF5D515-919D-C366-6C86-BD4A75AB91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8C415-FC8B-4006-BAC4-CA06FABFC2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899581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00B28C0-5EE6-5CDF-836E-99BFEEB0AA6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4BF0BB71-96F0-1E1F-8AFE-6F7E391C10A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652E404-564F-2BDB-7470-22C41E5213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FE34A3-6E95-4BE9-9402-403D8E3FBF59}" type="datetimeFigureOut">
              <a:rPr kumimoji="1" lang="ja-JP" altLang="en-US" smtClean="0"/>
              <a:t>2025/1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67DE8C2-AD48-73C6-60D3-073DB0E5C7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AB2C9E7-383B-C18D-7AD0-FEBCAD6C28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8C415-FC8B-4006-BAC4-CA06FABFC2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294452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D66D1CBC-D688-9DF4-9B11-465BC365E7F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A5F42B39-C53D-E035-0B7A-9BD77862F35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8910484-9A4F-7190-6DB9-82BAA0721E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FE34A3-6E95-4BE9-9402-403D8E3FBF59}" type="datetimeFigureOut">
              <a:rPr kumimoji="1" lang="ja-JP" altLang="en-US" smtClean="0"/>
              <a:t>2025/1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B08994F-2B61-B4EA-FB7A-E8DBE7BE6D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E7D057F-6476-43BD-42FF-938776CF99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8C415-FC8B-4006-BAC4-CA06FABFC2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377686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9992E8F-6635-E8C3-4E6E-E4ECF1CCAF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89134774-D629-519A-9662-45E4D24468E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DF96661-7FB3-5D10-AB5A-FF1158AAD0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FE34A3-6E95-4BE9-9402-403D8E3FBF59}" type="datetimeFigureOut">
              <a:rPr kumimoji="1" lang="ja-JP" altLang="en-US" smtClean="0"/>
              <a:t>2025/1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3BAB6C9-1247-A0EA-ED88-C757FE29C0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6FA1C5D-5F5D-8EC9-17E6-97BF7238FF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8C415-FC8B-4006-BAC4-CA06FABFC2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158579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ABD0509-6560-7597-5EB1-37AC8686E9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BEEBBECD-02FB-33DE-B91B-BE1B828E1E1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2CEB9B9-0DA3-E167-4359-DC9992C2CF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FE34A3-6E95-4BE9-9402-403D8E3FBF59}" type="datetimeFigureOut">
              <a:rPr kumimoji="1" lang="ja-JP" altLang="en-US" smtClean="0"/>
              <a:t>2025/1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7467FA7-42B9-150D-3B65-F48D9B3F2C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7794ABC-BA1D-DE13-B347-45440DA33E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8C415-FC8B-4006-BAC4-CA06FABFC2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835263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CCCC7A8-470C-0DE5-0B4A-F3412220CBC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CBCABBC3-6C16-4298-9F58-335BF4E4B00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7FF6023A-827E-AE6D-7CB6-C7C9984FA1D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A7FC92E2-4E69-3E32-A287-AC61A2885A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FE34A3-6E95-4BE9-9402-403D8E3FBF59}" type="datetimeFigureOut">
              <a:rPr kumimoji="1" lang="ja-JP" altLang="en-US" smtClean="0"/>
              <a:t>2025/1/1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7DA6AFBE-01CB-8592-0099-15649D61C4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E1876CA3-73B6-56D6-A6B0-8EE58FFDCC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8C415-FC8B-4006-BAC4-CA06FABFC2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132161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D5EF035-1693-EE4B-AB3D-542ED68333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6009A83F-D0C4-29C1-9D49-CBBC8F4D8AC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3FFC7CE5-56EA-F138-ECB0-78441E8C7B2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22176D51-4F7B-B5AD-454E-F2EAB9115F3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77F02553-FBDD-4C10-3A25-877E64E0775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3A8C6C6E-CEB9-25E5-5BE7-4CE9F2BD33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FE34A3-6E95-4BE9-9402-403D8E3FBF59}" type="datetimeFigureOut">
              <a:rPr kumimoji="1" lang="ja-JP" altLang="en-US" smtClean="0"/>
              <a:t>2025/1/13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BCEACFC1-5F5A-CBF2-197C-AC286579B7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79DD34F9-4C95-2D53-AE22-CFB6BAAD33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8C415-FC8B-4006-BAC4-CA06FABFC2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344573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C4AAD74-D3E0-3885-4A10-2FAF1E7DDD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EEC456DD-C355-8ECE-718D-198BAF2C6A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FE34A3-6E95-4BE9-9402-403D8E3FBF59}" type="datetimeFigureOut">
              <a:rPr kumimoji="1" lang="ja-JP" altLang="en-US" smtClean="0"/>
              <a:t>2025/1/13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50F51E23-23BD-E715-9FDD-3011B1AD82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59768BB4-7C0E-8F2C-0303-43E74EA579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8C415-FC8B-4006-BAC4-CA06FABFC2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496739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9E75D19F-9A19-F258-7308-F456211BA6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FE34A3-6E95-4BE9-9402-403D8E3FBF59}" type="datetimeFigureOut">
              <a:rPr kumimoji="1" lang="ja-JP" altLang="en-US" smtClean="0"/>
              <a:t>2025/1/13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94C04D07-4037-A049-75D8-B4AD63EF5D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ABCB3E21-445D-897F-F16A-DF1730EDCC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8C415-FC8B-4006-BAC4-CA06FABFC2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307110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76A490A-2D1C-9329-0E5D-AA01ABF4918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EF09DF9-F3D6-5C22-D8DF-81DDB87313C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68125D48-3A98-63CC-B186-F0EC666255D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51259B78-472D-97C1-7D62-91CFBFC775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FE34A3-6E95-4BE9-9402-403D8E3FBF59}" type="datetimeFigureOut">
              <a:rPr kumimoji="1" lang="ja-JP" altLang="en-US" smtClean="0"/>
              <a:t>2025/1/1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3C23B0B-F772-DE2E-2909-1CE16C0EE2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D12E3081-B461-A784-1297-A57BB26D28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8C415-FC8B-4006-BAC4-CA06FABFC2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238092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82B1568-39F3-32AF-E712-6059218251E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8C8E7F83-0B28-7E48-8067-B415FDB5879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7135BBD9-C401-0121-8572-6C80B809645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0E688ED0-FD3A-4ACD-4D69-01B39509B4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FE34A3-6E95-4BE9-9402-403D8E3FBF59}" type="datetimeFigureOut">
              <a:rPr kumimoji="1" lang="ja-JP" altLang="en-US" smtClean="0"/>
              <a:t>2025/1/1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3FE2EB2-DE3A-041E-FD19-AC7FC36121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82234510-10E7-208A-3DB0-B75C81D838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8C415-FC8B-4006-BAC4-CA06FABFC2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715247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6946E115-7354-7F20-67DB-118A82A92F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87FF49F-9C08-C600-9272-04B8B112452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68D4CBD-E72B-1327-FEB9-EBD816E84CF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4FE34A3-6E95-4BE9-9402-403D8E3FBF59}" type="datetimeFigureOut">
              <a:rPr kumimoji="1" lang="ja-JP" altLang="en-US" smtClean="0"/>
              <a:t>2025/1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EE94B7E-351F-DBDF-6CD3-D01F377F418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01B693F-F677-8548-B693-B56BE31755B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EA8C415-FC8B-4006-BAC4-CA06FABFC2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553939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 1">
            <a:extLst>
              <a:ext uri="{FF2B5EF4-FFF2-40B4-BE49-F238E27FC236}">
                <a16:creationId xmlns:a16="http://schemas.microsoft.com/office/drawing/2014/main" id="{F97D2449-369C-92E6-C975-C07816F7371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53482968"/>
              </p:ext>
            </p:extLst>
          </p:nvPr>
        </p:nvGraphicFramePr>
        <p:xfrm>
          <a:off x="713232" y="1810512"/>
          <a:ext cx="10405872" cy="3703318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093994">
                  <a:extLst>
                    <a:ext uri="{9D8B030D-6E8A-4147-A177-3AD203B41FA5}">
                      <a16:colId xmlns:a16="http://schemas.microsoft.com/office/drawing/2014/main" val="972737961"/>
                    </a:ext>
                  </a:extLst>
                </a:gridCol>
                <a:gridCol w="3539945">
                  <a:extLst>
                    <a:ext uri="{9D8B030D-6E8A-4147-A177-3AD203B41FA5}">
                      <a16:colId xmlns:a16="http://schemas.microsoft.com/office/drawing/2014/main" val="276950803"/>
                    </a:ext>
                  </a:extLst>
                </a:gridCol>
                <a:gridCol w="3771933">
                  <a:extLst>
                    <a:ext uri="{9D8B030D-6E8A-4147-A177-3AD203B41FA5}">
                      <a16:colId xmlns:a16="http://schemas.microsoft.com/office/drawing/2014/main" val="2204533295"/>
                    </a:ext>
                  </a:extLst>
                </a:gridCol>
              </a:tblGrid>
              <a:tr h="1225926">
                <a:tc>
                  <a:txBody>
                    <a:bodyPr/>
                    <a:lstStyle/>
                    <a:p>
                      <a:pPr algn="l"/>
                      <a:r>
                        <a:rPr lang="en-US" sz="24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uO</a:t>
                      </a:r>
                      <a:r>
                        <a:rPr lang="en-US" sz="2400" kern="100" baseline="-25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24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(mmHg)</a:t>
                      </a:r>
                      <a:endParaRPr lang="ja-JP" sz="24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4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rect fluid aspiration</a:t>
                      </a:r>
                      <a:endParaRPr lang="ja-JP" sz="24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4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luid aspiration through a </a:t>
                      </a:r>
                      <a:r>
                        <a:rPr lang="en-US" altLang="ja-JP" sz="24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C-coated</a:t>
                      </a:r>
                      <a:r>
                        <a:rPr lang="ja-JP" altLang="en-US" sz="24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24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dified urinary catheter</a:t>
                      </a:r>
                      <a:endParaRPr lang="ja-JP" sz="24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76068709"/>
                  </a:ext>
                </a:extLst>
              </a:tr>
              <a:tr h="552305">
                <a:tc>
                  <a:txBody>
                    <a:bodyPr/>
                    <a:lstStyle/>
                    <a:p>
                      <a:pPr algn="l"/>
                      <a:r>
                        <a:rPr lang="en-US" sz="24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rst measurement</a:t>
                      </a:r>
                      <a:endParaRPr lang="ja-JP" sz="24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4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1.9</a:t>
                      </a:r>
                      <a:endParaRPr lang="ja-JP" sz="24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24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78.8</a:t>
                      </a:r>
                      <a:endParaRPr lang="ja-JP" sz="24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17087152"/>
                  </a:ext>
                </a:extLst>
              </a:tr>
              <a:tr h="552305">
                <a:tc>
                  <a:txBody>
                    <a:bodyPr/>
                    <a:lstStyle/>
                    <a:p>
                      <a:pPr algn="l"/>
                      <a:r>
                        <a:rPr lang="en-US" sz="24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cond measurement</a:t>
                      </a:r>
                      <a:endParaRPr lang="ja-JP" sz="24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4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3.4</a:t>
                      </a:r>
                      <a:endParaRPr lang="ja-JP" sz="24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24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78.8</a:t>
                      </a:r>
                      <a:endParaRPr lang="ja-JP" sz="24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66607484"/>
                  </a:ext>
                </a:extLst>
              </a:tr>
              <a:tr h="552305">
                <a:tc>
                  <a:txBody>
                    <a:bodyPr/>
                    <a:lstStyle/>
                    <a:p>
                      <a:pPr algn="l"/>
                      <a:r>
                        <a:rPr lang="en-US" sz="24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ird measurement</a:t>
                      </a:r>
                      <a:endParaRPr lang="ja-JP" sz="24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24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62.8</a:t>
                      </a:r>
                      <a:endParaRPr lang="ja-JP" sz="24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24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82.1</a:t>
                      </a:r>
                      <a:endParaRPr lang="ja-JP" sz="24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03584622"/>
                  </a:ext>
                </a:extLst>
              </a:tr>
              <a:tr h="820477">
                <a:tc>
                  <a:txBody>
                    <a:bodyPr/>
                    <a:lstStyle/>
                    <a:p>
                      <a:pPr algn="l"/>
                      <a:r>
                        <a:rPr lang="en-US" sz="24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an ± standard deviation</a:t>
                      </a:r>
                      <a:endParaRPr lang="ja-JP" sz="24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4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9.4 ± 6.5</a:t>
                      </a:r>
                      <a:endParaRPr lang="ja-JP" sz="24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4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9.9 ± 1.9</a:t>
                      </a:r>
                      <a:endParaRPr lang="ja-JP" sz="24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98922026"/>
                  </a:ext>
                </a:extLst>
              </a:tr>
            </a:tbl>
          </a:graphicData>
        </a:graphic>
      </p:graphicFrame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2E42B936-B5CB-4C63-B432-4EE28429D4C7}"/>
              </a:ext>
            </a:extLst>
          </p:cNvPr>
          <p:cNvSpPr txBox="1"/>
          <p:nvPr/>
        </p:nvSpPr>
        <p:spPr>
          <a:xfrm>
            <a:off x="599440" y="9145"/>
            <a:ext cx="12192000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3200" b="1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Comparison of PuO</a:t>
            </a:r>
            <a:r>
              <a:rPr lang="en-US" altLang="ja-JP" sz="3200" b="1" baseline="-250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2</a:t>
            </a:r>
            <a:r>
              <a:rPr lang="en-US" altLang="ja-JP" sz="3200" b="1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 between direct fluid aspiration and fluid aspiration through a PVC-coated modified urinary catheter. </a:t>
            </a:r>
            <a:br>
              <a:rPr lang="en-US" altLang="ja-JP" sz="3200" b="1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</a:br>
            <a:r>
              <a:rPr lang="en-US" altLang="ja-JP" sz="3200" b="1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The fluid was adjusted to PuO</a:t>
            </a:r>
            <a:r>
              <a:rPr lang="en-US" altLang="ja-JP" sz="3200" b="1" baseline="-250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2</a:t>
            </a:r>
            <a:r>
              <a:rPr lang="en-US" altLang="ja-JP" sz="3200" b="1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 of 65 mmHg or less.</a:t>
            </a:r>
            <a:endParaRPr kumimoji="1" lang="ja-JP" altLang="en-US" sz="3200" b="1" dirty="0"/>
          </a:p>
        </p:txBody>
      </p:sp>
      <p:cxnSp>
        <p:nvCxnSpPr>
          <p:cNvPr id="7" name="直線コネクタ 6">
            <a:extLst>
              <a:ext uri="{FF2B5EF4-FFF2-40B4-BE49-F238E27FC236}">
                <a16:creationId xmlns:a16="http://schemas.microsoft.com/office/drawing/2014/main" id="{5AC434F2-079F-10B0-CC04-83359AFC161B}"/>
              </a:ext>
            </a:extLst>
          </p:cNvPr>
          <p:cNvCxnSpPr/>
          <p:nvPr/>
        </p:nvCxnSpPr>
        <p:spPr>
          <a:xfrm>
            <a:off x="721360" y="3068320"/>
            <a:ext cx="10383520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8" name="直線コネクタ 7">
            <a:extLst>
              <a:ext uri="{FF2B5EF4-FFF2-40B4-BE49-F238E27FC236}">
                <a16:creationId xmlns:a16="http://schemas.microsoft.com/office/drawing/2014/main" id="{741363ED-17FC-F990-F239-E82FF7D637F6}"/>
              </a:ext>
            </a:extLst>
          </p:cNvPr>
          <p:cNvCxnSpPr/>
          <p:nvPr/>
        </p:nvCxnSpPr>
        <p:spPr>
          <a:xfrm>
            <a:off x="721360" y="4704080"/>
            <a:ext cx="10383520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7590041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2</TotalTime>
  <Words>67</Words>
  <Application>Microsoft Office PowerPoint</Application>
  <PresentationFormat>ワイド画面</PresentationFormat>
  <Paragraphs>16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崇央 加藤</dc:creator>
  <cp:lastModifiedBy>崇央 加藤</cp:lastModifiedBy>
  <cp:revision>1</cp:revision>
  <dcterms:created xsi:type="dcterms:W3CDTF">2025-01-13T12:36:05Z</dcterms:created>
  <dcterms:modified xsi:type="dcterms:W3CDTF">2025-01-13T13:08:57Z</dcterms:modified>
</cp:coreProperties>
</file>